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-152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0A5749-B8B7-6A4F-BAAA-392D1200EB7B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DAEA51-B41E-4946-B81B-09C9CE632A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787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0408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04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964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6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9340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1415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6353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5879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0371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9335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311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C108CA-307C-5C4C-BBB0-EA556BBD7A34}" type="datetimeFigureOut">
              <a:rPr kumimoji="1" lang="ja-JP" altLang="en-US" smtClean="0"/>
              <a:t>2016/0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5EA37-16EC-C443-87E2-3C801E1EF6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198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75200" y="1702296"/>
            <a:ext cx="3911600" cy="2836973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257" y="1702296"/>
            <a:ext cx="4439600" cy="2836973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120325"/>
            <a:ext cx="8229600" cy="1143000"/>
          </a:xfrm>
        </p:spPr>
        <p:txBody>
          <a:bodyPr>
            <a:normAutofit/>
          </a:bodyPr>
          <a:lstStyle/>
          <a:p>
            <a:r>
              <a:rPr kumimoji="1" lang="en-US" altLang="ja-JP" dirty="0" smtClean="0"/>
              <a:t>Supplemental Data Figure 2. </a:t>
            </a:r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-1068490" y="2866739"/>
            <a:ext cx="2752332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DPP4 mRNA/GAPDH mRNA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020782" y="4539269"/>
            <a:ext cx="1008911" cy="64633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Medium alone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029693" y="4539269"/>
            <a:ext cx="1270040" cy="64633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IL-13</a:t>
            </a:r>
          </a:p>
          <a:p>
            <a:pPr algn="ctr"/>
            <a:r>
              <a:rPr kumimoji="1" lang="en-US" altLang="ja-JP" dirty="0" smtClean="0"/>
              <a:t>(10ng/ml)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299733" y="4539269"/>
            <a:ext cx="1270040" cy="120032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MF(10µM)</a:t>
            </a:r>
          </a:p>
          <a:p>
            <a:pPr algn="ctr"/>
            <a:r>
              <a:rPr lang="en-US" altLang="ja-JP" dirty="0" smtClean="0"/>
              <a:t>+</a:t>
            </a:r>
          </a:p>
          <a:p>
            <a:pPr algn="ctr"/>
            <a:r>
              <a:rPr kumimoji="1" lang="en-US" altLang="ja-JP" dirty="0" smtClean="0"/>
              <a:t>IL-13</a:t>
            </a:r>
          </a:p>
          <a:p>
            <a:pPr algn="ctr"/>
            <a:r>
              <a:rPr kumimoji="1" lang="en-US" altLang="ja-JP" dirty="0" smtClean="0"/>
              <a:t>(10ng/ml)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218993" y="4514215"/>
            <a:ext cx="1008911" cy="64633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Medium alone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227904" y="4514215"/>
            <a:ext cx="1270040" cy="64633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IL-13</a:t>
            </a:r>
          </a:p>
          <a:p>
            <a:pPr algn="ctr"/>
            <a:r>
              <a:rPr kumimoji="1" lang="en-US" altLang="ja-JP" dirty="0" smtClean="0"/>
              <a:t>(10ng/ml)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7497944" y="4514215"/>
            <a:ext cx="1270040" cy="120032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MF(10µM)</a:t>
            </a:r>
          </a:p>
          <a:p>
            <a:pPr algn="ctr"/>
            <a:r>
              <a:rPr lang="en-US" altLang="ja-JP" dirty="0" smtClean="0"/>
              <a:t>+</a:t>
            </a:r>
          </a:p>
          <a:p>
            <a:pPr algn="ctr"/>
            <a:r>
              <a:rPr kumimoji="1" lang="en-US" altLang="ja-JP" dirty="0" smtClean="0"/>
              <a:t>IL-13</a:t>
            </a:r>
          </a:p>
          <a:p>
            <a:pPr algn="ctr"/>
            <a:r>
              <a:rPr kumimoji="1" lang="en-US" altLang="ja-JP" dirty="0" smtClean="0"/>
              <a:t>(10ng/ml)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3983401" y="2862462"/>
            <a:ext cx="1583599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DPP4 (</a:t>
            </a:r>
            <a:r>
              <a:rPr lang="en-US" altLang="ja-JP" dirty="0" err="1" smtClean="0"/>
              <a:t>ng</a:t>
            </a:r>
            <a:r>
              <a:rPr lang="en-US" altLang="ja-JP" dirty="0" smtClean="0"/>
              <a:t>/ml)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644370" y="1513457"/>
            <a:ext cx="609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*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473264" y="6107069"/>
            <a:ext cx="4584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*P&lt;0.01 </a:t>
            </a:r>
            <a:r>
              <a:rPr kumimoji="1" lang="en-US" altLang="ja-JP" dirty="0" err="1" smtClean="0"/>
              <a:t>vs</a:t>
            </a:r>
            <a:r>
              <a:rPr kumimoji="1" lang="en-US" altLang="ja-JP" dirty="0" smtClean="0"/>
              <a:t> medium alone, MF+ IL-13 (N=4)</a:t>
            </a:r>
            <a:endParaRPr kumimoji="1" lang="ja-JP" altLang="en-US" dirty="0"/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6765640" y="1517630"/>
            <a:ext cx="609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*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9231209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06</TotalTime>
  <Words>82</Words>
  <Application>Microsoft Macintosh PowerPoint</Application>
  <PresentationFormat>画面に合わせる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Supplemental Data Figure 2. </vt:lpstr>
    </vt:vector>
  </TitlesOfParts>
  <Company>Dokky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Data 1</dc:title>
  <dc:creator>知花 和行</dc:creator>
  <cp:lastModifiedBy>Kazuyuki Chibana</cp:lastModifiedBy>
  <cp:revision>28</cp:revision>
  <dcterms:created xsi:type="dcterms:W3CDTF">2015-12-07T13:18:16Z</dcterms:created>
  <dcterms:modified xsi:type="dcterms:W3CDTF">2016-02-08T20:57:07Z</dcterms:modified>
</cp:coreProperties>
</file>